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794500" cy="99822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075">
          <p15:clr>
            <a:srgbClr val="A4A3A4"/>
          </p15:clr>
        </p15:guide>
        <p15:guide id="2" pos="2976">
          <p15:clr>
            <a:srgbClr val="A4A3A4"/>
          </p15:clr>
        </p15:guide>
        <p15:guide id="3" orient="horz" pos="1306">
          <p15:clr>
            <a:srgbClr val="A4A3A4"/>
          </p15:clr>
        </p15:guide>
        <p15:guide id="4" pos="5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49" autoAdjust="0"/>
    <p:restoredTop sz="94238" autoAdjust="0"/>
  </p:normalViewPr>
  <p:slideViewPr>
    <p:cSldViewPr>
      <p:cViewPr>
        <p:scale>
          <a:sx n="50" d="100"/>
          <a:sy n="50" d="100"/>
        </p:scale>
        <p:origin x="-2244" y="-12"/>
      </p:cViewPr>
      <p:guideLst>
        <p:guide orient="horz" pos="3075"/>
        <p:guide orient="horz" pos="1306"/>
        <p:guide pos="2976"/>
        <p:guide pos="57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 w="127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4B4-41EB-BE5E-AED35833749B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4B4-41EB-BE5E-AED35833749B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4B4-41EB-BE5E-AED35833749B}"/>
              </c:ext>
            </c:extLst>
          </c:dPt>
          <c:errBars>
            <c:errBarType val="plus"/>
            <c:errValType val="cust"/>
            <c:noEndCap val="0"/>
            <c:plus>
              <c:numRef>
                <c:f>'ata-Expression'!$C$7:$H$7</c:f>
                <c:numCache>
                  <c:formatCode>General</c:formatCode>
                  <c:ptCount val="6"/>
                  <c:pt idx="0">
                    <c:v>0.42523162212404236</c:v>
                  </c:pt>
                  <c:pt idx="1">
                    <c:v>7.7711453759890428E-4</c:v>
                  </c:pt>
                  <c:pt idx="2">
                    <c:v>3.4761907685298826E-3</c:v>
                  </c:pt>
                  <c:pt idx="3">
                    <c:v>9.4765467875301183E-4</c:v>
                  </c:pt>
                  <c:pt idx="4">
                    <c:v>0.21140177175463559</c:v>
                  </c:pt>
                  <c:pt idx="5">
                    <c:v>1.1204576886512505</c:v>
                  </c:pt>
                </c:numCache>
              </c:numRef>
            </c:plus>
            <c:minus>
              <c:numRef>
                <c:f>'ata-Expression'!$C$7:$H$7</c:f>
                <c:numCache>
                  <c:formatCode>General</c:formatCode>
                  <c:ptCount val="6"/>
                  <c:pt idx="0">
                    <c:v>0.42523162212404236</c:v>
                  </c:pt>
                  <c:pt idx="1">
                    <c:v>7.7711453759890428E-4</c:v>
                  </c:pt>
                  <c:pt idx="2">
                    <c:v>3.4761907685298826E-3</c:v>
                  </c:pt>
                  <c:pt idx="3">
                    <c:v>9.4765467875301183E-4</c:v>
                  </c:pt>
                  <c:pt idx="4">
                    <c:v>0.21140177175463559</c:v>
                  </c:pt>
                  <c:pt idx="5">
                    <c:v>1.1204576886512505</c:v>
                  </c:pt>
                </c:numCache>
              </c:numRef>
            </c:minus>
            <c:spPr>
              <a:ln w="12700"/>
            </c:spPr>
          </c:errBars>
          <c:cat>
            <c:strRef>
              <c:f>'ata-Expression'!$C$4:$H$4</c:f>
              <c:strCache>
                <c:ptCount val="6"/>
                <c:pt idx="0">
                  <c:v>WT</c:v>
                </c:pt>
                <c:pt idx="1">
                  <c:v>∆ata</c:v>
                </c:pt>
                <c:pt idx="2">
                  <c:v>∆ata (p) -</c:v>
                </c:pt>
                <c:pt idx="3">
                  <c:v>∆ata (p) +</c:v>
                </c:pt>
                <c:pt idx="4">
                  <c:v>∆ata (c) -</c:v>
                </c:pt>
                <c:pt idx="5">
                  <c:v>∆ata (c) +</c:v>
                </c:pt>
              </c:strCache>
            </c:strRef>
          </c:cat>
          <c:val>
            <c:numRef>
              <c:f>'ata-Expression'!$C$5:$H$5</c:f>
              <c:numCache>
                <c:formatCode>0.00</c:formatCode>
                <c:ptCount val="6"/>
                <c:pt idx="0">
                  <c:v>2.2555509001869822</c:v>
                </c:pt>
                <c:pt idx="1">
                  <c:v>1.7441440969695897E-3</c:v>
                </c:pt>
                <c:pt idx="2">
                  <c:v>9.6651445001456737E-3</c:v>
                </c:pt>
                <c:pt idx="3">
                  <c:v>4.2281234086761427E-3</c:v>
                </c:pt>
                <c:pt idx="4">
                  <c:v>0.37639073492978653</c:v>
                </c:pt>
                <c:pt idx="5">
                  <c:v>3.26757807213506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64B4-41EB-BE5E-AED3583374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4759552"/>
        <c:axId val="114761088"/>
      </c:barChart>
      <c:catAx>
        <c:axId val="114759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 rot="-2700000" vert="horz"/>
          <a:lstStyle/>
          <a:p>
            <a:pPr>
              <a:defRPr b="1"/>
            </a:pPr>
            <a:endParaRPr lang="de-DE"/>
          </a:p>
        </c:txPr>
        <c:crossAx val="114761088"/>
        <c:crosses val="autoZero"/>
        <c:auto val="1"/>
        <c:lblAlgn val="ctr"/>
        <c:lblOffset val="100"/>
        <c:noMultiLvlLbl val="0"/>
      </c:catAx>
      <c:valAx>
        <c:axId val="114761088"/>
        <c:scaling>
          <c:orientation val="minMax"/>
          <c:max val="5"/>
          <c:min val="0"/>
        </c:scaling>
        <c:delete val="0"/>
        <c:axPos val="l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1" i="0" baseline="0" dirty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n-US" sz="800" b="1" i="1" baseline="0" dirty="0" err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ta</a:t>
                </a:r>
                <a:r>
                  <a:rPr lang="en-US" sz="800" b="1" i="0" baseline="0" dirty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expression </a:t>
                </a: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1" i="0" baseline="0" dirty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compared to </a:t>
                </a:r>
                <a:r>
                  <a:rPr lang="en-US" sz="800" b="1" i="1" baseline="0" dirty="0" err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poB</a:t>
                </a:r>
                <a:endParaRPr lang="en-US" sz="800" b="1" dirty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 b="1" dirty="0"/>
              </a:p>
            </c:rich>
          </c:tx>
          <c:layout>
            <c:manualLayout>
              <c:xMode val="edge"/>
              <c:yMode val="edge"/>
              <c:x val="5.1939682539682543E-2"/>
              <c:y val="0.1641442251504102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de-DE"/>
          </a:p>
        </c:txPr>
        <c:crossAx val="114759552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169736-5EA0-4F0C-A671-14FACB21B4DE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749300"/>
            <a:ext cx="25908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60EAFD-4791-471C-895E-5F1F35E566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344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60EAFD-4791-471C-895E-5F1F35E5661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73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163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5252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4882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1542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938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3939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4608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5848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1067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2577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782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0218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8.png"/><Relationship Id="rId18" Type="http://schemas.microsoft.com/office/2007/relationships/hdphoto" Target="../media/hdphoto4.wdp"/><Relationship Id="rId3" Type="http://schemas.openxmlformats.org/officeDocument/2006/relationships/chart" Target="../charts/chart1.xml"/><Relationship Id="rId21" Type="http://schemas.microsoft.com/office/2007/relationships/hdphoto" Target="../media/hdphoto5.wdp"/><Relationship Id="rId7" Type="http://schemas.openxmlformats.org/officeDocument/2006/relationships/image" Target="../media/image4.png"/><Relationship Id="rId12" Type="http://schemas.microsoft.com/office/2007/relationships/hdphoto" Target="../media/hdphoto2.wdp"/><Relationship Id="rId1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6" Type="http://schemas.microsoft.com/office/2007/relationships/hdphoto" Target="../media/hdphoto3.wdp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5" Type="http://schemas.openxmlformats.org/officeDocument/2006/relationships/image" Target="../media/image2.png"/><Relationship Id="rId15" Type="http://schemas.openxmlformats.org/officeDocument/2006/relationships/image" Target="../media/image10.png"/><Relationship Id="rId10" Type="http://schemas.openxmlformats.org/officeDocument/2006/relationships/image" Target="../media/image6.png"/><Relationship Id="rId19" Type="http://schemas.openxmlformats.org/officeDocument/2006/relationships/image" Target="../media/image12.png"/><Relationship Id="rId4" Type="http://schemas.openxmlformats.org/officeDocument/2006/relationships/image" Target="../media/image1.png"/><Relationship Id="rId9" Type="http://schemas.openxmlformats.org/officeDocument/2006/relationships/image" Target="../media/image5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feld 63"/>
          <p:cNvSpPr txBox="1"/>
          <p:nvPr/>
        </p:nvSpPr>
        <p:spPr>
          <a:xfrm>
            <a:off x="0" y="211505"/>
            <a:ext cx="29567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densdorfer </a:t>
            </a:r>
            <a:r>
              <a:rPr lang="de-DE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Supplement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</a:t>
            </a:r>
          </a:p>
        </p:txBody>
      </p:sp>
      <p:sp>
        <p:nvSpPr>
          <p:cNvPr id="65" name="Rechteck 64"/>
          <p:cNvSpPr/>
          <p:nvPr/>
        </p:nvSpPr>
        <p:spPr>
          <a:xfrm>
            <a:off x="216024" y="5842352"/>
            <a:ext cx="6453336" cy="36471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4. </a:t>
            </a:r>
            <a:r>
              <a:rPr lang="en-US" sz="1100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Markerless</a:t>
            </a:r>
            <a:r>
              <a:rPr lang="en-US" sz="1100" b="1">
                <a:latin typeface="Times New Roman" panose="02020603050405020304" pitchFamily="18" charset="0"/>
                <a:ea typeface="Calibri" panose="020F0502020204030204" pitchFamily="34" charset="0"/>
              </a:rPr>
              <a:t> deletion of </a:t>
            </a:r>
            <a:r>
              <a:rPr lang="en-US" sz="1100" b="1" i="1">
                <a:latin typeface="Times New Roman" panose="02020603050405020304" pitchFamily="18" charset="0"/>
                <a:ea typeface="Calibri" panose="020F0502020204030204" pitchFamily="34" charset="0"/>
              </a:rPr>
              <a:t>ata</a:t>
            </a:r>
            <a:r>
              <a:rPr lang="en-US" sz="1100" b="1">
                <a:latin typeface="Times New Roman" panose="02020603050405020304" pitchFamily="18" charset="0"/>
                <a:ea typeface="Calibri" panose="020F0502020204030204" pitchFamily="34" charset="0"/>
              </a:rPr>
              <a:t> and generation of complemented strains.</a:t>
            </a:r>
            <a:r>
              <a:rPr lang="en-US" sz="1100" b="1">
                <a:latin typeface="Times New Roman" panose="02020603050405020304" pitchFamily="18" charset="0"/>
                <a:ea typeface="Arial" panose="020B0604020202020204" pitchFamily="34" charset="0"/>
              </a:rPr>
              <a:t> </a:t>
            </a:r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Verification of </a:t>
            </a:r>
            <a:r>
              <a:rPr lang="en-US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letion by PCR and restriction analysis of constructed plasmids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mic or plasmid DNA was isolated from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 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umannii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CC 19606 WT an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_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) an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_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. The coding sequence of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,777 bps) was amplified with primers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_seq_fw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_seq_rev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detected in WT (lane 1), but not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ane 2). The restriction patterns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K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K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_∆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ne 4-7), isolated from the transformed ∆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ains indicate the successful construction of the restoration plasmid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Transcriptional analysis of </a:t>
            </a:r>
            <a:r>
              <a:rPr lang="en-US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RNA of the indicated strains were isolated after 2 h of incubation with (+) or without (-) 0.5% arabinose. The amount of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was calculated by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d normalized to the expression of the reference gene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o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alues are means ± SEM of six independent experiments; asterisks (*) indicate statistically significant differences (p&lt;0.05) calculated via a two-tailed t-test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urface-localized Ata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indicated strains were grown with or without arabinose for 2 h and fixed with paraformaldehyde. Surface exposed Ata was detected with anti-Ata-head antibodies and stained with secondary Alexa 488-conjugated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 rabbit antibody. Bacterial DNA was stained with DAPI (blue). Samples were analyzed by fluorescence microscopy.</a:t>
            </a:r>
          </a:p>
        </p:txBody>
      </p:sp>
      <p:sp>
        <p:nvSpPr>
          <p:cNvPr id="112" name="Textfeld 111"/>
          <p:cNvSpPr txBox="1"/>
          <p:nvPr/>
        </p:nvSpPr>
        <p:spPr>
          <a:xfrm>
            <a:off x="4642798" y="1627096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3" name="Runde Klammer links 112"/>
          <p:cNvSpPr/>
          <p:nvPr/>
        </p:nvSpPr>
        <p:spPr>
          <a:xfrm rot="5400000">
            <a:off x="4601077" y="1760936"/>
            <a:ext cx="45719" cy="274314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Textfeld 113"/>
          <p:cNvSpPr txBox="1"/>
          <p:nvPr/>
        </p:nvSpPr>
        <p:spPr>
          <a:xfrm>
            <a:off x="4511565" y="1744275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5" name="Runde Klammer links 114"/>
          <p:cNvSpPr/>
          <p:nvPr/>
        </p:nvSpPr>
        <p:spPr>
          <a:xfrm rot="5400000">
            <a:off x="4732310" y="1512003"/>
            <a:ext cx="45719" cy="535621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unde Klammer links 115"/>
          <p:cNvSpPr/>
          <p:nvPr/>
        </p:nvSpPr>
        <p:spPr>
          <a:xfrm rot="5400000">
            <a:off x="4875746" y="1241176"/>
            <a:ext cx="45719" cy="823654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Textfeld 116"/>
          <p:cNvSpPr txBox="1"/>
          <p:nvPr/>
        </p:nvSpPr>
        <p:spPr>
          <a:xfrm>
            <a:off x="4798237" y="1499759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aphicFrame>
        <p:nvGraphicFramePr>
          <p:cNvPr id="66" name="Diagramm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46299"/>
              </p:ext>
            </p:extLst>
          </p:nvPr>
        </p:nvGraphicFramePr>
        <p:xfrm>
          <a:off x="3660971" y="1250118"/>
          <a:ext cx="2520000" cy="1944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4" name="Textfeld 83"/>
          <p:cNvSpPr txBox="1"/>
          <p:nvPr/>
        </p:nvSpPr>
        <p:spPr>
          <a:xfrm>
            <a:off x="476193" y="9778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3364409" y="98088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476193" y="30283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Gruppieren 87"/>
          <p:cNvGrpSpPr/>
          <p:nvPr/>
        </p:nvGrpSpPr>
        <p:grpSpPr>
          <a:xfrm>
            <a:off x="883859" y="3346663"/>
            <a:ext cx="5102512" cy="2085611"/>
            <a:chOff x="869480" y="4961966"/>
            <a:chExt cx="5102512" cy="2085611"/>
          </a:xfrm>
        </p:grpSpPr>
        <p:sp>
          <p:nvSpPr>
            <p:cNvPr id="89" name="Textfeld 88"/>
            <p:cNvSpPr txBox="1"/>
            <p:nvPr/>
          </p:nvSpPr>
          <p:spPr>
            <a:xfrm>
              <a:off x="1396043" y="4961966"/>
              <a:ext cx="293576" cy="184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0" name="Textfeld 89"/>
            <p:cNvSpPr txBox="1"/>
            <p:nvPr/>
          </p:nvSpPr>
          <p:spPr>
            <a:xfrm>
              <a:off x="2639819" y="4961966"/>
              <a:ext cx="348399" cy="184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ta</a:t>
              </a:r>
            </a:p>
          </p:txBody>
        </p:sp>
        <p:sp>
          <p:nvSpPr>
            <p:cNvPr id="92" name="Textfeld 91"/>
            <p:cNvSpPr txBox="1"/>
            <p:nvPr/>
          </p:nvSpPr>
          <p:spPr>
            <a:xfrm>
              <a:off x="3843162" y="4961966"/>
              <a:ext cx="484085" cy="184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ta (p)</a:t>
              </a:r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5116405" y="4961966"/>
              <a:ext cx="479973" cy="184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ta (c)</a:t>
              </a:r>
            </a:p>
          </p:txBody>
        </p:sp>
        <p:pic>
          <p:nvPicPr>
            <p:cNvPr id="94" name="Picture 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27231" y="5160170"/>
              <a:ext cx="1231200" cy="1231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5" name="Picture 7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27231" y="6436447"/>
              <a:ext cx="590940" cy="59094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6" name="Picture 8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67491" y="6436447"/>
              <a:ext cx="590940" cy="59094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7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8418" y="5160170"/>
              <a:ext cx="1231200" cy="1231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8" name="Picture 11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8418" y="6436447"/>
              <a:ext cx="590940" cy="59094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9" name="Picture 12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38042" y="6436447"/>
              <a:ext cx="591576" cy="59157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0" name="Picture 13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69604" y="5160170"/>
              <a:ext cx="1231200" cy="1231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1" name="Picture 14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69604" y="6436447"/>
              <a:ext cx="591576" cy="59157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2" name="Picture 15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09229" y="6436447"/>
              <a:ext cx="591576" cy="59157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3" name="Picture 16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40791" y="5160170"/>
              <a:ext cx="1231200" cy="1231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4" name="Picture 17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25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40791" y="6436447"/>
              <a:ext cx="591576" cy="59157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5" name="Picture 18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81052" y="6436447"/>
              <a:ext cx="590940" cy="59094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06" name="Textfeld 105"/>
            <p:cNvSpPr txBox="1"/>
            <p:nvPr/>
          </p:nvSpPr>
          <p:spPr>
            <a:xfrm>
              <a:off x="869480" y="6228150"/>
              <a:ext cx="416927" cy="184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870456" y="6863372"/>
              <a:ext cx="367587" cy="184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08" name="Textfeld 107"/>
            <p:cNvSpPr txBox="1"/>
            <p:nvPr/>
          </p:nvSpPr>
          <p:spPr>
            <a:xfrm>
              <a:off x="1577889" y="6863372"/>
              <a:ext cx="397739" cy="184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-488</a:t>
              </a:r>
            </a:p>
          </p:txBody>
        </p:sp>
        <p:grpSp>
          <p:nvGrpSpPr>
            <p:cNvPr id="109" name="Gruppieren 108"/>
            <p:cNvGrpSpPr/>
            <p:nvPr/>
          </p:nvGrpSpPr>
          <p:grpSpPr>
            <a:xfrm>
              <a:off x="5563239" y="6154800"/>
              <a:ext cx="385403" cy="184205"/>
              <a:chOff x="5857509" y="4079117"/>
              <a:chExt cx="450764" cy="215444"/>
            </a:xfrm>
          </p:grpSpPr>
          <p:cxnSp>
            <p:nvCxnSpPr>
              <p:cNvPr id="110" name="Gerader Verbinder 19"/>
              <p:cNvCxnSpPr/>
              <p:nvPr/>
            </p:nvCxnSpPr>
            <p:spPr>
              <a:xfrm>
                <a:off x="5990833" y="4284676"/>
                <a:ext cx="24968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Textfeld 110"/>
              <p:cNvSpPr txBox="1"/>
              <p:nvPr/>
            </p:nvSpPr>
            <p:spPr>
              <a:xfrm>
                <a:off x="5857509" y="4079117"/>
                <a:ext cx="4507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  µm</a:t>
                </a:r>
              </a:p>
            </p:txBody>
          </p:sp>
        </p:grpSp>
      </p:grpSp>
      <p:grpSp>
        <p:nvGrpSpPr>
          <p:cNvPr id="118" name="Gruppieren 117"/>
          <p:cNvGrpSpPr>
            <a:grpSpLocks noChangeAspect="1"/>
          </p:cNvGrpSpPr>
          <p:nvPr/>
        </p:nvGrpSpPr>
        <p:grpSpPr>
          <a:xfrm>
            <a:off x="857455" y="527140"/>
            <a:ext cx="2172428" cy="2158753"/>
            <a:chOff x="692696" y="110773"/>
            <a:chExt cx="1974933" cy="1962503"/>
          </a:xfrm>
        </p:grpSpPr>
        <p:sp>
          <p:nvSpPr>
            <p:cNvPr id="119" name="Textfeld 118"/>
            <p:cNvSpPr txBox="1"/>
            <p:nvPr/>
          </p:nvSpPr>
          <p:spPr>
            <a:xfrm rot="16200000">
              <a:off x="1837513" y="640475"/>
              <a:ext cx="1311221" cy="251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∆ata (c) 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ut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ith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b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DE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m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r>
                <a:rPr lang="de-DE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/ </a:t>
              </a:r>
              <a:r>
                <a:rPr lang="de-DE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ba</a:t>
              </a:r>
              <a:r>
                <a:rPr lang="de-DE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0" name="Gruppieren 119"/>
            <p:cNvGrpSpPr/>
            <p:nvPr/>
          </p:nvGrpSpPr>
          <p:grpSpPr>
            <a:xfrm>
              <a:off x="692696" y="387774"/>
              <a:ext cx="1974933" cy="1685502"/>
              <a:chOff x="692696" y="387774"/>
              <a:chExt cx="1974933" cy="1685502"/>
            </a:xfrm>
          </p:grpSpPr>
          <p:sp>
            <p:nvSpPr>
              <p:cNvPr id="121" name="Textfeld 120"/>
              <p:cNvSpPr txBox="1"/>
              <p:nvPr/>
            </p:nvSpPr>
            <p:spPr>
              <a:xfrm rot="16200000">
                <a:off x="722987" y="994472"/>
                <a:ext cx="6703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 </a:t>
                </a:r>
                <a:r>
                  <a:rPr lang="de-DE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bp</a:t>
                </a:r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marker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Textfeld 121"/>
              <p:cNvSpPr txBox="1"/>
              <p:nvPr/>
            </p:nvSpPr>
            <p:spPr>
              <a:xfrm rot="16200000">
                <a:off x="1122454" y="1178016"/>
                <a:ext cx="30328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Textfeld 122"/>
              <p:cNvSpPr txBox="1"/>
              <p:nvPr/>
            </p:nvSpPr>
            <p:spPr>
              <a:xfrm rot="16200000">
                <a:off x="1268168" y="1157979"/>
                <a:ext cx="34336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∆ata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Textfeld 123"/>
              <p:cNvSpPr txBox="1"/>
              <p:nvPr/>
            </p:nvSpPr>
            <p:spPr>
              <a:xfrm rot="16200000">
                <a:off x="1652378" y="1098668"/>
                <a:ext cx="46198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∆ata (p)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feld 124"/>
              <p:cNvSpPr txBox="1"/>
              <p:nvPr/>
            </p:nvSpPr>
            <p:spPr>
              <a:xfrm rot="16200000">
                <a:off x="2066817" y="1100271"/>
                <a:ext cx="4587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∆ata (c)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feld 125"/>
              <p:cNvSpPr txBox="1"/>
              <p:nvPr/>
            </p:nvSpPr>
            <p:spPr>
              <a:xfrm rot="16200000">
                <a:off x="1543319" y="778975"/>
                <a:ext cx="1034220" cy="2518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∆ata (p) </a:t>
                </a:r>
                <a:r>
                  <a:rPr lang="de-DE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ut</a:t>
                </a:r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ith</a:t>
                </a:r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b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lang="de-DE" sz="6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m</a:t>
                </a:r>
                <a:r>
                  <a:rPr lang="de-DE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/ </a:t>
                </a:r>
                <a:r>
                  <a:rPr lang="de-DE" sz="6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Xba</a:t>
                </a:r>
                <a:r>
                  <a:rPr lang="de-DE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feld 126"/>
              <p:cNvSpPr txBox="1"/>
              <p:nvPr/>
            </p:nvSpPr>
            <p:spPr>
              <a:xfrm>
                <a:off x="692696" y="1427316"/>
                <a:ext cx="271228" cy="1261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Textfeld 127"/>
              <p:cNvSpPr txBox="1"/>
              <p:nvPr/>
            </p:nvSpPr>
            <p:spPr>
              <a:xfrm>
                <a:off x="735977" y="1508160"/>
                <a:ext cx="227947" cy="1261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29" name="Textfeld 128"/>
              <p:cNvSpPr txBox="1"/>
              <p:nvPr/>
            </p:nvSpPr>
            <p:spPr>
              <a:xfrm>
                <a:off x="735977" y="1597060"/>
                <a:ext cx="227947" cy="1261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30" name="Textfeld 129"/>
              <p:cNvSpPr txBox="1"/>
              <p:nvPr/>
            </p:nvSpPr>
            <p:spPr>
              <a:xfrm>
                <a:off x="735977" y="1672804"/>
                <a:ext cx="227947" cy="1261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1" name="Textfeld 130"/>
              <p:cNvSpPr txBox="1"/>
              <p:nvPr/>
            </p:nvSpPr>
            <p:spPr>
              <a:xfrm>
                <a:off x="735977" y="1755354"/>
                <a:ext cx="227947" cy="1261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32" name="Textfeld 131"/>
              <p:cNvSpPr txBox="1"/>
              <p:nvPr/>
            </p:nvSpPr>
            <p:spPr>
              <a:xfrm>
                <a:off x="735977" y="1874183"/>
                <a:ext cx="227947" cy="1261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33" name="Textfeld 132"/>
              <p:cNvSpPr txBox="1"/>
              <p:nvPr/>
            </p:nvSpPr>
            <p:spPr>
              <a:xfrm rot="16200000">
                <a:off x="1266862" y="940772"/>
                <a:ext cx="77777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</a:t>
                </a:r>
                <a:r>
                  <a:rPr lang="de-DE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6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4" name="Picture 2" descr="C:\Users\Admin\Dropbox\AG Wichelhaus\Marko\Paper\Abbildungen\ata-PCR_pARKM_ata-Restriktion.tif"/>
              <p:cNvPicPr>
                <a:picLocks noChangeAspect="1" noChangeArrowheads="1"/>
              </p:cNvPicPr>
              <p:nvPr/>
            </p:nvPicPr>
            <p:blipFill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45000" contrast="-1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11729" y="1357094"/>
                <a:ext cx="1755900" cy="71618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</p:grpSp>
      <p:sp>
        <p:nvSpPr>
          <p:cNvPr id="135" name="Textfeld 134"/>
          <p:cNvSpPr txBox="1"/>
          <p:nvPr/>
        </p:nvSpPr>
        <p:spPr>
          <a:xfrm>
            <a:off x="1361304" y="2506608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6" name="Textfeld 135"/>
          <p:cNvSpPr txBox="1"/>
          <p:nvPr/>
        </p:nvSpPr>
        <p:spPr>
          <a:xfrm>
            <a:off x="1589242" y="2506608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37" name="Textfeld 136"/>
          <p:cNvSpPr txBox="1"/>
          <p:nvPr/>
        </p:nvSpPr>
        <p:spPr>
          <a:xfrm>
            <a:off x="1817180" y="2506608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8" name="Textfeld 137"/>
          <p:cNvSpPr txBox="1"/>
          <p:nvPr/>
        </p:nvSpPr>
        <p:spPr>
          <a:xfrm>
            <a:off x="2045118" y="2506608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39" name="Textfeld 138"/>
          <p:cNvSpPr txBox="1"/>
          <p:nvPr/>
        </p:nvSpPr>
        <p:spPr>
          <a:xfrm>
            <a:off x="2273056" y="2506608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0" name="Textfeld 139"/>
          <p:cNvSpPr txBox="1"/>
          <p:nvPr/>
        </p:nvSpPr>
        <p:spPr>
          <a:xfrm>
            <a:off x="2500994" y="2506608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41" name="Textfeld 140"/>
          <p:cNvSpPr txBox="1"/>
          <p:nvPr/>
        </p:nvSpPr>
        <p:spPr>
          <a:xfrm>
            <a:off x="2728930" y="2506608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25" name="Runde Klammer links 52">
            <a:extLst>
              <a:ext uri="{FF2B5EF4-FFF2-40B4-BE49-F238E27FC236}">
                <a16:creationId xmlns="" xmlns:a16="http://schemas.microsoft.com/office/drawing/2014/main" id="{7FF25D8C-FC1D-4BB8-BFE1-29087FF079A3}"/>
              </a:ext>
            </a:extLst>
          </p:cNvPr>
          <p:cNvSpPr/>
          <p:nvPr/>
        </p:nvSpPr>
        <p:spPr>
          <a:xfrm rot="5400000">
            <a:off x="5028098" y="944694"/>
            <a:ext cx="45719" cy="1140069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Textfeld 225">
            <a:extLst>
              <a:ext uri="{FF2B5EF4-FFF2-40B4-BE49-F238E27FC236}">
                <a16:creationId xmlns="" xmlns:a16="http://schemas.microsoft.com/office/drawing/2014/main" id="{00726653-1C50-4FC1-A0F6-A9288C198B4E}"/>
              </a:ext>
            </a:extLst>
          </p:cNvPr>
          <p:cNvSpPr txBox="1"/>
          <p:nvPr/>
        </p:nvSpPr>
        <p:spPr>
          <a:xfrm>
            <a:off x="4919769" y="1365784"/>
            <a:ext cx="3110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47849413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A4-Papier (210x297 mm)</PresentationFormat>
  <Paragraphs>41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ktoranten</dc:creator>
  <cp:lastModifiedBy>SGoettig</cp:lastModifiedBy>
  <cp:revision>97</cp:revision>
  <cp:lastPrinted>2018-04-11T08:19:40Z</cp:lastPrinted>
  <dcterms:created xsi:type="dcterms:W3CDTF">2018-02-22T12:55:07Z</dcterms:created>
  <dcterms:modified xsi:type="dcterms:W3CDTF">2018-11-19T21:51:53Z</dcterms:modified>
</cp:coreProperties>
</file>